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256" r:id="rId3"/>
  </p:sldIdLst>
  <p:sldSz cx="6858000" cy="9903460" type="A4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78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90" y="96"/>
      </p:cViewPr>
      <p:guideLst>
        <p:guide orient="horz" pos="3119"/>
        <p:guide pos="212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56781" y="1279525"/>
            <a:ext cx="239208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857250" y="1910571"/>
            <a:ext cx="5143500" cy="3158383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45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857250" y="5201925"/>
            <a:ext cx="5143500" cy="2391188"/>
          </a:xfrm>
        </p:spPr>
        <p:txBody>
          <a:bodyPr>
            <a:normAutofit/>
          </a:bodyPr>
          <a:lstStyle>
            <a:lvl1pPr marL="0" indent="0" algn="ctr">
              <a:buNone/>
              <a:defRPr sz="135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j-lt"/>
                <a:ea typeface="+mj-ea"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471488" y="796517"/>
            <a:ext cx="5915025" cy="8028052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64331" y="373236"/>
            <a:ext cx="5915025" cy="1914327"/>
          </a:xfrm>
        </p:spPr>
        <p:txBody>
          <a:bodyPr anchor="ctr" anchorCtr="0">
            <a:normAutofit/>
          </a:bodyPr>
          <a:lstStyle>
            <a:lvl1pPr>
              <a:defRPr sz="18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64331" y="2636497"/>
            <a:ext cx="5915025" cy="6284035"/>
          </a:xfrm>
        </p:spPr>
        <p:txBody>
          <a:bodyPr>
            <a:normAutofit/>
          </a:bodyPr>
          <a:lstStyle>
            <a:lvl1pPr>
              <a:defRPr sz="15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5417219"/>
            <a:ext cx="4118372" cy="1171731"/>
          </a:xfrm>
        </p:spPr>
        <p:txBody>
          <a:bodyPr anchor="b">
            <a:normAutofit/>
          </a:bodyPr>
          <a:lstStyle>
            <a:lvl1pPr>
              <a:defRPr sz="3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57625"/>
            <a:ext cx="4118372" cy="935174"/>
          </a:xfrm>
        </p:spPr>
        <p:txBody>
          <a:bodyPr>
            <a:normAutofit/>
          </a:bodyPr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64331" y="373236"/>
            <a:ext cx="5915025" cy="1914327"/>
          </a:xfrm>
        </p:spPr>
        <p:txBody>
          <a:bodyPr>
            <a:normAutofit/>
          </a:bodyPr>
          <a:lstStyle>
            <a:lvl1pPr>
              <a:defRPr sz="1800" b="1" i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64331" y="2636497"/>
            <a:ext cx="2914650" cy="6284035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15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364706" y="2636497"/>
            <a:ext cx="2914650" cy="6284035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15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15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150000"/>
              </a:lnSpc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150000"/>
              </a:lnSpc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150000"/>
              </a:lnSpc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299"/>
            <a:ext cx="5915025" cy="191432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520005"/>
            <a:ext cx="2901255" cy="11898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777362"/>
            <a:ext cx="2901255" cy="516151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520005"/>
            <a:ext cx="2915543" cy="11898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777362"/>
            <a:ext cx="2915543" cy="516151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488" y="3994867"/>
            <a:ext cx="5915025" cy="1914327"/>
          </a:xfrm>
        </p:spPr>
        <p:txBody>
          <a:bodyPr>
            <a:normAutofit/>
          </a:bodyPr>
          <a:lstStyle>
            <a:lvl1pPr algn="ctr">
              <a:defRPr sz="3600" b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363795" y="183409"/>
            <a:ext cx="2342925" cy="2310947"/>
          </a:xfrm>
        </p:spPr>
        <p:txBody>
          <a:bodyPr anchor="ctr" anchorCtr="0">
            <a:normAutofit/>
          </a:bodyPr>
          <a:lstStyle>
            <a:lvl1pPr>
              <a:defRPr sz="18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2916000" y="1106739"/>
            <a:ext cx="3272273" cy="7357203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66653" y="2971218"/>
            <a:ext cx="2342925" cy="5504549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cxnSp>
        <p:nvCxnSpPr>
          <p:cNvPr id="8" name="直接连接符 7" hidden="1"/>
          <p:cNvCxnSpPr/>
          <p:nvPr userDrawn="1"/>
        </p:nvCxnSpPr>
        <p:spPr>
          <a:xfrm>
            <a:off x="417909" y="627257"/>
            <a:ext cx="0" cy="20092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526272" y="527299"/>
            <a:ext cx="860240" cy="8393233"/>
          </a:xfrm>
        </p:spPr>
        <p:txBody>
          <a:bodyPr vert="eaVert">
            <a:normAutofit/>
          </a:bodyPr>
          <a:lstStyle>
            <a:lvl1pPr>
              <a:defRPr sz="27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527299"/>
            <a:ext cx="4994976" cy="8393233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299"/>
            <a:ext cx="5915025" cy="19143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6497"/>
            <a:ext cx="5915025" cy="62840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79596"/>
            <a:ext cx="1543050" cy="5272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79596"/>
            <a:ext cx="2314575" cy="5272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79596"/>
            <a:ext cx="1543050" cy="5272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" name="组合 1"/>
          <p:cNvGrpSpPr/>
          <p:nvPr/>
        </p:nvGrpSpPr>
        <p:grpSpPr>
          <a:xfrm>
            <a:off x="118110" y="374015"/>
            <a:ext cx="6727190" cy="9500235"/>
            <a:chOff x="186" y="589"/>
            <a:chExt cx="10594" cy="14961"/>
          </a:xfrm>
        </p:grpSpPr>
        <p:sp>
          <p:nvSpPr>
            <p:cNvPr id="4" name="文本框 3"/>
            <p:cNvSpPr txBox="1"/>
            <p:nvPr/>
          </p:nvSpPr>
          <p:spPr>
            <a:xfrm>
              <a:off x="1286" y="589"/>
              <a:ext cx="3412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/>
                <a:t>GSE134839</a:t>
              </a:r>
              <a:endParaRPr lang="en-US" altLang="zh-CN" sz="1200"/>
            </a:p>
          </p:txBody>
        </p:sp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710" y="1600"/>
              <a:ext cx="4563" cy="1701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 rot="10800000">
              <a:off x="236" y="1484"/>
              <a:ext cx="578" cy="184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pPr algn="ctr"/>
              <a:r>
                <a:rPr lang="en-US" altLang="zh-CN" sz="1200"/>
                <a:t>CL-Impute</a:t>
              </a:r>
              <a:endParaRPr lang="en-US" altLang="zh-CN" sz="1200"/>
            </a:p>
          </p:txBody>
        </p:sp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77" y="3863"/>
              <a:ext cx="4629" cy="17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82" y="6125"/>
              <a:ext cx="4618" cy="1700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 rot="10800000">
              <a:off x="236" y="3646"/>
              <a:ext cx="578" cy="211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pPr algn="ctr"/>
              <a:r>
                <a:rPr lang="en-US" altLang="zh-CN" sz="1200"/>
                <a:t>CMFImpute</a:t>
              </a:r>
              <a:endParaRPr lang="en-US" altLang="zh-CN" sz="1200"/>
            </a:p>
          </p:txBody>
        </p:sp>
        <p:sp>
          <p:nvSpPr>
            <p:cNvPr id="10" name="文本框 9"/>
            <p:cNvSpPr txBox="1"/>
            <p:nvPr/>
          </p:nvSpPr>
          <p:spPr>
            <a:xfrm rot="10800000">
              <a:off x="256" y="6067"/>
              <a:ext cx="578" cy="184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pPr algn="ctr"/>
              <a:r>
                <a:rPr lang="en-US" altLang="zh-CN" sz="1200"/>
                <a:t>GEImpute</a:t>
              </a:r>
              <a:endParaRPr lang="en-US" altLang="zh-CN" sz="1200"/>
            </a:p>
          </p:txBody>
        </p:sp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1" y="8387"/>
              <a:ext cx="4600" cy="1700"/>
            </a:xfrm>
            <a:prstGeom prst="rect">
              <a:avLst/>
            </a:prstGeom>
          </p:spPr>
        </p:pic>
        <p:sp>
          <p:nvSpPr>
            <p:cNvPr id="12" name="文本框 11"/>
            <p:cNvSpPr txBox="1"/>
            <p:nvPr/>
          </p:nvSpPr>
          <p:spPr>
            <a:xfrm rot="10800000">
              <a:off x="236" y="8308"/>
              <a:ext cx="578" cy="184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pPr algn="ctr"/>
              <a:r>
                <a:rPr lang="en-US" altLang="zh-CN" sz="1200"/>
                <a:t>MAGICImpute</a:t>
              </a:r>
              <a:endParaRPr lang="en-US" altLang="zh-CN" sz="1200"/>
            </a:p>
          </p:txBody>
        </p:sp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04" y="10649"/>
              <a:ext cx="4574" cy="1700"/>
            </a:xfrm>
            <a:prstGeom prst="rect">
              <a:avLst/>
            </a:prstGeom>
          </p:spPr>
        </p:pic>
        <p:sp>
          <p:nvSpPr>
            <p:cNvPr id="14" name="文本框 13"/>
            <p:cNvSpPr txBox="1"/>
            <p:nvPr/>
          </p:nvSpPr>
          <p:spPr>
            <a:xfrm rot="10800000">
              <a:off x="269" y="10562"/>
              <a:ext cx="578" cy="184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pPr algn="ctr"/>
              <a:r>
                <a:rPr lang="en-US" altLang="zh-CN" sz="1200"/>
                <a:t>scGCL</a:t>
              </a:r>
              <a:endParaRPr lang="en-US" altLang="zh-CN" sz="1200"/>
            </a:p>
          </p:txBody>
        </p: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90" y="12911"/>
              <a:ext cx="4603" cy="1700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 rot="10800000">
              <a:off x="251" y="12658"/>
              <a:ext cx="578" cy="229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pPr algn="ctr"/>
              <a:r>
                <a:rPr lang="en-US" altLang="zh-CN" sz="1200"/>
                <a:t>SCRABBLE</a:t>
              </a:r>
              <a:endParaRPr lang="en-US" altLang="zh-CN" sz="1200"/>
            </a:p>
          </p:txBody>
        </p:sp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650" y="1600"/>
              <a:ext cx="4704" cy="1701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724" y="10649"/>
              <a:ext cx="4742" cy="1700"/>
            </a:xfrm>
            <a:prstGeom prst="rect">
              <a:avLst/>
            </a:prstGeom>
          </p:spPr>
        </p:pic>
        <p:pic>
          <p:nvPicPr>
            <p:cNvPr id="22" name="图片 2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724" y="12911"/>
              <a:ext cx="4736" cy="1700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724" y="1600"/>
              <a:ext cx="4704" cy="1701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724" y="3863"/>
              <a:ext cx="4773" cy="1700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724" y="6125"/>
              <a:ext cx="4694" cy="1700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724" y="8387"/>
              <a:ext cx="4699" cy="1700"/>
            </a:xfrm>
            <a:prstGeom prst="rect">
              <a:avLst/>
            </a:prstGeom>
          </p:spPr>
        </p:pic>
        <p:sp>
          <p:nvSpPr>
            <p:cNvPr id="27" name="文本框 26"/>
            <p:cNvSpPr txBox="1"/>
            <p:nvPr/>
          </p:nvSpPr>
          <p:spPr>
            <a:xfrm>
              <a:off x="6296" y="589"/>
              <a:ext cx="3412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/>
                <a:t>GSE134841</a:t>
              </a:r>
              <a:endParaRPr lang="en-US" altLang="zh-CN" sz="1200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206" y="1214"/>
              <a:ext cx="444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True label              Clustering results</a:t>
              </a:r>
              <a:endParaRPr lang="en-US" altLang="zh-CN" sz="1200"/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6281" y="1214"/>
              <a:ext cx="444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True label              Clustering results</a:t>
              </a:r>
              <a:endParaRPr lang="en-US" altLang="zh-CN" sz="1200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186" y="14825"/>
              <a:ext cx="10594" cy="7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/>
                <a:t>Supplementary figure 1: UMAP plots of unsupervised clustering and true labels in GSE134839 and GSE134841 datasets</a:t>
              </a:r>
              <a:endParaRPr lang="en-US" altLang="zh-CN" sz="120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 Black-Arial">
      <a:majorFont>
        <a:latin typeface="Arial Black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微软雅黑"/>
        <a:ea typeface=""/>
        <a:cs typeface=""/>
        <a:font script="Jpan" typeface="游ゴシック Light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微软雅黑"/>
        <a:ea typeface=""/>
        <a:cs typeface=""/>
        <a:font script="Jpan" typeface="游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5</Words>
  <Application>WPS 演示</Application>
  <PresentationFormat>宽屏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微软雅黑</vt:lpstr>
      <vt:lpstr>Arial Unicode MS</vt:lpstr>
      <vt:lpstr>Arial Black</vt:lpstr>
      <vt:lpstr>黑体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admin</cp:lastModifiedBy>
  <cp:revision>7</cp:revision>
  <dcterms:created xsi:type="dcterms:W3CDTF">2024-02-01T10:39:00Z</dcterms:created>
  <dcterms:modified xsi:type="dcterms:W3CDTF">2024-03-20T12:43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8.2.8361</vt:lpwstr>
  </property>
</Properties>
</file>